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handoutMasterIdLst>
    <p:handoutMasterId r:id="rId8"/>
  </p:handoutMasterIdLst>
  <p:sldIdLst>
    <p:sldId id="270" r:id="rId2"/>
    <p:sldId id="269" r:id="rId3"/>
    <p:sldId id="271" r:id="rId4"/>
    <p:sldId id="272" r:id="rId5"/>
    <p:sldId id="266" r:id="rId6"/>
  </p:sldIdLst>
  <p:sldSz cx="9144000" cy="6858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298">
          <p15:clr>
            <a:srgbClr val="A4A3A4"/>
          </p15:clr>
        </p15:guide>
        <p15:guide id="2" pos="476" userDrawn="1">
          <p15:clr>
            <a:srgbClr val="A4A3A4"/>
          </p15:clr>
        </p15:guide>
        <p15:guide id="3" pos="5420">
          <p15:clr>
            <a:srgbClr val="A4A3A4"/>
          </p15:clr>
        </p15:guide>
        <p15:guide id="4" pos="505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CF076"/>
    <a:srgbClr val="FFFF66"/>
    <a:srgbClr val="CCFF66"/>
    <a:srgbClr val="CCFF33"/>
    <a:srgbClr val="558ED5"/>
    <a:srgbClr val="C83C0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>
        <p:scale>
          <a:sx n="74" d="100"/>
          <a:sy n="74" d="100"/>
        </p:scale>
        <p:origin x="-1034" y="26"/>
      </p:cViewPr>
      <p:guideLst>
        <p:guide orient="horz" pos="3298"/>
        <p:guide pos="476"/>
        <p:guide pos="5420"/>
        <p:guide pos="505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090229-AC47-435D-A39C-1D32C4A8C386}" type="datetimeFigureOut">
              <a:rPr lang="en-GB" smtClean="0"/>
              <a:t>27/09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41B999A-63D7-4FED-80B4-DF6A226F429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560423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6A2EB39-401A-4408-A555-82D860AE4B24}" type="datetimeFigureOut">
              <a:rPr lang="en-GB" smtClean="0"/>
              <a:t>27/09/2017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219B1BB-2D8C-406F-80A4-A203517400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93243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219B1BB-2D8C-406F-80A4-A20351740059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50346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F6BBB-B0CF-45B8-8943-B17417F2E2CA}" type="datetimeFigureOut">
              <a:rPr lang="en-GB" smtClean="0"/>
              <a:t>27/09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F0422-B7D1-4D2D-A179-DEA5B57BD6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16414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F6BBB-B0CF-45B8-8943-B17417F2E2CA}" type="datetimeFigureOut">
              <a:rPr lang="en-GB" smtClean="0"/>
              <a:t>27/09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F0422-B7D1-4D2D-A179-DEA5B57BD6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51316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F6BBB-B0CF-45B8-8943-B17417F2E2CA}" type="datetimeFigureOut">
              <a:rPr lang="en-GB" smtClean="0"/>
              <a:t>27/09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F0422-B7D1-4D2D-A179-DEA5B57BD6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131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F6BBB-B0CF-45B8-8943-B17417F2E2CA}" type="datetimeFigureOut">
              <a:rPr lang="en-GB" smtClean="0"/>
              <a:t>27/09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F0422-B7D1-4D2D-A179-DEA5B57BD6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38673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F6BBB-B0CF-45B8-8943-B17417F2E2CA}" type="datetimeFigureOut">
              <a:rPr lang="en-GB" smtClean="0"/>
              <a:t>27/09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F0422-B7D1-4D2D-A179-DEA5B57BD6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24593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F6BBB-B0CF-45B8-8943-B17417F2E2CA}" type="datetimeFigureOut">
              <a:rPr lang="en-GB" smtClean="0"/>
              <a:t>27/09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F0422-B7D1-4D2D-A179-DEA5B57BD6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79073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F6BBB-B0CF-45B8-8943-B17417F2E2CA}" type="datetimeFigureOut">
              <a:rPr lang="en-GB" smtClean="0"/>
              <a:t>27/09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F0422-B7D1-4D2D-A179-DEA5B57BD6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9089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F6BBB-B0CF-45B8-8943-B17417F2E2CA}" type="datetimeFigureOut">
              <a:rPr lang="en-GB" smtClean="0"/>
              <a:t>27/09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F0422-B7D1-4D2D-A179-DEA5B57BD6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6532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F6BBB-B0CF-45B8-8943-B17417F2E2CA}" type="datetimeFigureOut">
              <a:rPr lang="en-GB" smtClean="0"/>
              <a:t>27/09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F0422-B7D1-4D2D-A179-DEA5B57BD6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40809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F6BBB-B0CF-45B8-8943-B17417F2E2CA}" type="datetimeFigureOut">
              <a:rPr lang="en-GB" smtClean="0"/>
              <a:t>27/09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F0422-B7D1-4D2D-A179-DEA5B57BD6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44538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F6BBB-B0CF-45B8-8943-B17417F2E2CA}" type="datetimeFigureOut">
              <a:rPr lang="en-GB" smtClean="0"/>
              <a:t>27/09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3F0422-B7D1-4D2D-A179-DEA5B57BD6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98515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6F6BBB-B0CF-45B8-8943-B17417F2E2CA}" type="datetimeFigureOut">
              <a:rPr lang="en-GB" smtClean="0"/>
              <a:t>27/09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3F0422-B7D1-4D2D-A179-DEA5B57BD6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7144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tiff"/><Relationship Id="rId5" Type="http://schemas.openxmlformats.org/officeDocument/2006/relationships/image" Target="../media/image7.tiff"/><Relationship Id="rId4" Type="http://schemas.openxmlformats.org/officeDocument/2006/relationships/image" Target="../media/image6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jpg"/><Relationship Id="rId4" Type="http://schemas.openxmlformats.org/officeDocument/2006/relationships/image" Target="../media/image11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jpg"/><Relationship Id="rId4" Type="http://schemas.openxmlformats.org/officeDocument/2006/relationships/image" Target="../media/image1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25"/>
          <a:stretch/>
        </p:blipFill>
        <p:spPr bwMode="auto">
          <a:xfrm>
            <a:off x="1043607" y="1097257"/>
            <a:ext cx="4589485" cy="296862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" name="Straight Arrow Connector 4"/>
          <p:cNvCxnSpPr/>
          <p:nvPr/>
        </p:nvCxnSpPr>
        <p:spPr>
          <a:xfrm flipV="1">
            <a:off x="558161" y="1944148"/>
            <a:ext cx="0" cy="1512168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 rot="16200000">
            <a:off x="-378387" y="2497760"/>
            <a:ext cx="1531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uc</a:t>
            </a:r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. activity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2627784" y="4065885"/>
            <a:ext cx="1172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‰ DMSO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9203" y="7353"/>
            <a:ext cx="28360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1.</a:t>
            </a:r>
            <a:endParaRPr lang="en-GB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778655" y="357301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78655" y="3262610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28962" y="2952204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728962" y="2647404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53394" y="2334369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753369" y="2033339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750251" y="1717526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750251" y="140171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750251" y="1108719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6598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1720" y="1124402"/>
            <a:ext cx="4896544" cy="1872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1720" y="3645024"/>
            <a:ext cx="4895649" cy="18722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9203" y="7353"/>
            <a:ext cx="28360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2.</a:t>
            </a:r>
            <a:endParaRPr lang="en-GB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588046" y="539547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588046" y="3140968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735211" y="1085761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738749" y="1310182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736409" y="155183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736409" y="178044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735402" y="2011352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736409" y="2236668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727260" y="2469043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736409" y="270892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736012" y="3625649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739550" y="3850070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737210" y="409172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737210" y="432032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736203" y="4551240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737210" y="4776556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28061" y="5008931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737210" y="524880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121695" y="829481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2534294" y="83056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939669" y="82703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340362" y="82793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750652" y="82703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4167611" y="82793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564716" y="82793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4967473" y="82703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5377576" y="832811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5730301" y="82703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6148861" y="832811"/>
            <a:ext cx="3701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6557511" y="829480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2121695" y="334256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2534294" y="334365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2939669" y="334012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3340362" y="334102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3750652" y="334012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4167611" y="334102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4564716" y="334102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4967473" y="334012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5377576" y="334589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5730301" y="334012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6148861" y="3345896"/>
            <a:ext cx="3701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6557511" y="3342565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7128284" y="1427258"/>
            <a:ext cx="216024" cy="1158861"/>
          </a:xfrm>
          <a:prstGeom prst="rect">
            <a:avLst/>
          </a:prstGeom>
          <a:gradFill>
            <a:gsLst>
              <a:gs pos="0">
                <a:srgbClr val="00B050"/>
              </a:gs>
              <a:gs pos="50000">
                <a:srgbClr val="FFFF00">
                  <a:lumMod val="100000"/>
                </a:srgbClr>
              </a:gs>
              <a:gs pos="100000">
                <a:srgbClr val="FF0000"/>
              </a:gs>
            </a:gsLst>
            <a:lin ang="5400000" scaled="0"/>
          </a:gra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" name="TextBox 2"/>
          <p:cNvSpPr txBox="1"/>
          <p:nvPr/>
        </p:nvSpPr>
        <p:spPr>
          <a:xfrm>
            <a:off x="7325789" y="1279404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7327056" y="243864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Rectangle 49"/>
          <p:cNvSpPr/>
          <p:nvPr/>
        </p:nvSpPr>
        <p:spPr>
          <a:xfrm>
            <a:off x="7111032" y="3971809"/>
            <a:ext cx="216024" cy="1158861"/>
          </a:xfrm>
          <a:prstGeom prst="rect">
            <a:avLst/>
          </a:prstGeom>
          <a:gradFill>
            <a:gsLst>
              <a:gs pos="0">
                <a:srgbClr val="00B050"/>
              </a:gs>
              <a:gs pos="85000">
                <a:srgbClr val="DCF076"/>
              </a:gs>
              <a:gs pos="90000">
                <a:srgbClr val="FF0000">
                  <a:lumMod val="100000"/>
                </a:srgbClr>
              </a:gs>
            </a:gsLst>
            <a:lin ang="5400000" scaled="0"/>
          </a:gra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2" name="TextBox 51"/>
          <p:cNvSpPr txBox="1"/>
          <p:nvPr/>
        </p:nvSpPr>
        <p:spPr>
          <a:xfrm>
            <a:off x="7301454" y="499403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7311828" y="3850070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7296156" y="476608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63857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9203" y="7353"/>
            <a:ext cx="28360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3.</a:t>
            </a:r>
            <a:endParaRPr lang="en-GB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Group 9"/>
          <p:cNvGrpSpPr/>
          <p:nvPr/>
        </p:nvGrpSpPr>
        <p:grpSpPr>
          <a:xfrm>
            <a:off x="2123728" y="1500592"/>
            <a:ext cx="3377568" cy="3556425"/>
            <a:chOff x="2123728" y="1500592"/>
            <a:chExt cx="3377568" cy="3556425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16" t="25911" r="51175"/>
            <a:stretch/>
          </p:blipFill>
          <p:spPr bwMode="auto">
            <a:xfrm>
              <a:off x="2123728" y="1556792"/>
              <a:ext cx="2232248" cy="3500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" name="TextBox 1"/>
            <p:cNvSpPr txBox="1"/>
            <p:nvPr/>
          </p:nvSpPr>
          <p:spPr>
            <a:xfrm>
              <a:off x="4355977" y="3298014"/>
              <a:ext cx="46480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 smtClean="0">
                  <a:latin typeface="Verdana" panose="020B0604030504040204" pitchFamily="34" charset="0"/>
                  <a:ea typeface="Verdana" panose="020B0604030504040204" pitchFamily="34" charset="0"/>
                  <a:cs typeface="Verdana" panose="020B0604030504040204" pitchFamily="34" charset="0"/>
                </a:rPr>
                <a:t>SA</a:t>
              </a:r>
              <a:endParaRPr lang="en-GB" sz="16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4355976" y="2510148"/>
              <a:ext cx="43313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 smtClean="0">
                  <a:latin typeface="Verdana" panose="020B0604030504040204" pitchFamily="34" charset="0"/>
                  <a:ea typeface="Verdana" panose="020B0604030504040204" pitchFamily="34" charset="0"/>
                  <a:cs typeface="Verdana" panose="020B0604030504040204" pitchFamily="34" charset="0"/>
                </a:rPr>
                <a:t>F1</a:t>
              </a:r>
              <a:endParaRPr lang="en-GB" sz="16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endParaRPr>
            </a:p>
          </p:txBody>
        </p:sp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69768" y="1500592"/>
              <a:ext cx="627520" cy="796752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28128" y="2381177"/>
              <a:ext cx="573168" cy="611461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38704" y="3174000"/>
              <a:ext cx="657167" cy="611461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73520" y="3970944"/>
              <a:ext cx="725107" cy="611461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4409280" y="4107397"/>
              <a:ext cx="3257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 smtClean="0">
                  <a:latin typeface="Verdana" panose="020B0604030504040204" pitchFamily="34" charset="0"/>
                  <a:ea typeface="Verdana" panose="020B0604030504040204" pitchFamily="34" charset="0"/>
                  <a:cs typeface="Verdana" panose="020B0604030504040204" pitchFamily="34" charset="0"/>
                </a:rPr>
                <a:t>A</a:t>
              </a:r>
              <a:endParaRPr lang="en-GB" sz="16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425515" y="1729691"/>
              <a:ext cx="3257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dirty="0" smtClean="0">
                  <a:latin typeface="Verdana" panose="020B0604030504040204" pitchFamily="34" charset="0"/>
                  <a:ea typeface="Verdana" panose="020B0604030504040204" pitchFamily="34" charset="0"/>
                  <a:cs typeface="Verdana" panose="020B0604030504040204" pitchFamily="34" charset="0"/>
                </a:rPr>
                <a:t>B</a:t>
              </a:r>
              <a:endParaRPr lang="en-GB" sz="1600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913748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51791" y="7353"/>
            <a:ext cx="28360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4.</a:t>
            </a:r>
            <a:endParaRPr lang="en-GB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7373446" y="711746"/>
            <a:ext cx="1230804" cy="216024"/>
          </a:xfrm>
          <a:prstGeom prst="rect">
            <a:avLst/>
          </a:prstGeom>
          <a:solidFill>
            <a:srgbClr val="FFFF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DMSO</a:t>
            </a:r>
            <a:endParaRPr lang="en-GB" sz="1200" dirty="0">
              <a:solidFill>
                <a:schemeClr val="tx1"/>
              </a:solidFill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7373446" y="1071885"/>
            <a:ext cx="1230804" cy="216024"/>
          </a:xfrm>
          <a:prstGeom prst="rect">
            <a:avLst/>
          </a:prstGeom>
          <a:solidFill>
            <a:schemeClr val="accent3">
              <a:lumMod val="7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F1</a:t>
            </a:r>
            <a:endParaRPr lang="en-GB" sz="1200" dirty="0">
              <a:solidFill>
                <a:schemeClr val="tx1"/>
              </a:solidFill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96336" y="1357888"/>
            <a:ext cx="845045" cy="9381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Rectangle 5"/>
          <p:cNvSpPr/>
          <p:nvPr/>
        </p:nvSpPr>
        <p:spPr>
          <a:xfrm>
            <a:off x="7373446" y="1287909"/>
            <a:ext cx="1224160" cy="1080120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Rectangle 11"/>
          <p:cNvSpPr/>
          <p:nvPr/>
        </p:nvSpPr>
        <p:spPr>
          <a:xfrm>
            <a:off x="7373644" y="2512045"/>
            <a:ext cx="1230804" cy="216024"/>
          </a:xfrm>
          <a:prstGeom prst="rect">
            <a:avLst/>
          </a:prstGeom>
          <a:solidFill>
            <a:schemeClr val="tx2">
              <a:lumMod val="60000"/>
              <a:lumOff val="40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Compound A</a:t>
            </a:r>
            <a:endParaRPr lang="en-GB" sz="1200" dirty="0">
              <a:solidFill>
                <a:schemeClr val="tx1"/>
              </a:solidFill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7373644" y="2728069"/>
            <a:ext cx="1224160" cy="1080120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Rectangle 14"/>
          <p:cNvSpPr/>
          <p:nvPr/>
        </p:nvSpPr>
        <p:spPr>
          <a:xfrm>
            <a:off x="7380312" y="3933056"/>
            <a:ext cx="1230804" cy="216024"/>
          </a:xfrm>
          <a:prstGeom prst="rect">
            <a:avLst/>
          </a:prstGeom>
          <a:solidFill>
            <a:srgbClr val="FFC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smtClean="0">
                <a:solidFill>
                  <a:schemeClr val="tx1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Compound B</a:t>
            </a:r>
            <a:endParaRPr lang="en-GB" sz="1200" dirty="0">
              <a:solidFill>
                <a:schemeClr val="tx1"/>
              </a:solidFill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7380312" y="4149080"/>
            <a:ext cx="1224160" cy="1080120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8055" y="721574"/>
            <a:ext cx="6749717" cy="45214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42596" y="2759105"/>
            <a:ext cx="1155010" cy="1035743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71677" y="4157706"/>
            <a:ext cx="695531" cy="10714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433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11693" y="908720"/>
            <a:ext cx="5520613" cy="33123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2339752" y="4149080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707904" y="4124067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F1-4F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148064" y="4131191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372200" y="414908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29163" y="4530045"/>
            <a:ext cx="808030" cy="1491243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53433" y="4518412"/>
            <a:ext cx="1221793" cy="1095629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13326" y="4500523"/>
            <a:ext cx="940421" cy="1448757"/>
          </a:xfrm>
          <a:prstGeom prst="rect">
            <a:avLst/>
          </a:prstGeom>
        </p:spPr>
      </p:pic>
      <p:cxnSp>
        <p:nvCxnSpPr>
          <p:cNvPr id="14" name="Straight Arrow Connector 13"/>
          <p:cNvCxnSpPr/>
          <p:nvPr/>
        </p:nvCxnSpPr>
        <p:spPr>
          <a:xfrm flipV="1">
            <a:off x="1811693" y="1808820"/>
            <a:ext cx="0" cy="1512168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 rot="16200000">
            <a:off x="798719" y="2227564"/>
            <a:ext cx="1531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uc</a:t>
            </a:r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. activity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9203" y="7353"/>
            <a:ext cx="28360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Figure 5.</a:t>
            </a:r>
            <a:endParaRPr lang="en-GB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39044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827</TotalTime>
  <Words>99</Words>
  <Application>Microsoft Office PowerPoint</Application>
  <PresentationFormat>On-screen Show (4:3)</PresentationFormat>
  <Paragraphs>77</Paragraphs>
  <Slides>5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Wageningen U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iers, Martijn</dc:creator>
  <cp:lastModifiedBy>Richard Immink</cp:lastModifiedBy>
  <cp:revision>113</cp:revision>
  <cp:lastPrinted>2017-09-04T13:09:57Z</cp:lastPrinted>
  <dcterms:created xsi:type="dcterms:W3CDTF">2014-09-30T15:33:43Z</dcterms:created>
  <dcterms:modified xsi:type="dcterms:W3CDTF">2017-09-27T19:56:50Z</dcterms:modified>
</cp:coreProperties>
</file>